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0" d="100"/>
          <a:sy n="80" d="100"/>
        </p:scale>
        <p:origin x="74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F4334-B2D8-48FC-BDC8-490A04B696FA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5828E-E324-4889-9B51-0A3A62521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5921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F4334-B2D8-48FC-BDC8-490A04B696FA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5828E-E324-4889-9B51-0A3A62521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80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F4334-B2D8-48FC-BDC8-490A04B696FA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5828E-E324-4889-9B51-0A3A62521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2634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F4334-B2D8-48FC-BDC8-490A04B696FA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5828E-E324-4889-9B51-0A3A62521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0543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F4334-B2D8-48FC-BDC8-490A04B696FA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5828E-E324-4889-9B51-0A3A62521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6994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F4334-B2D8-48FC-BDC8-490A04B696FA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5828E-E324-4889-9B51-0A3A62521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800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F4334-B2D8-48FC-BDC8-490A04B696FA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5828E-E324-4889-9B51-0A3A62521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0260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F4334-B2D8-48FC-BDC8-490A04B696FA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5828E-E324-4889-9B51-0A3A62521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8298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F4334-B2D8-48FC-BDC8-490A04B696FA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5828E-E324-4889-9B51-0A3A62521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2089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F4334-B2D8-48FC-BDC8-490A04B696FA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5828E-E324-4889-9B51-0A3A62521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8960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F4334-B2D8-48FC-BDC8-490A04B696FA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5828E-E324-4889-9B51-0A3A62521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575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5F4334-B2D8-48FC-BDC8-490A04B696FA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25828E-E324-4889-9B51-0A3A62521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6046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10693226"/>
              </p:ext>
            </p:extLst>
          </p:nvPr>
        </p:nvGraphicFramePr>
        <p:xfrm>
          <a:off x="7274846" y="765203"/>
          <a:ext cx="3311588" cy="253822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126731"/>
                <a:gridCol w="1184857"/>
              </a:tblGrid>
              <a:tr h="196405">
                <a:tc>
                  <a:txBody>
                    <a:bodyPr/>
                    <a:lstStyle/>
                    <a:p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regulated</a:t>
                      </a:r>
                      <a:r>
                        <a:rPr lang="en-US" sz="1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ogical Process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bined Score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146567">
                <a:tc>
                  <a:txBody>
                    <a:bodyPr/>
                    <a:lstStyle/>
                    <a:p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lammatory response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7027" marR="27027" marT="13513" marB="13513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7027" marR="27027" marT="13513" marB="13513" anchor="ctr"/>
                </a:tc>
              </a:tr>
              <a:tr h="196405">
                <a:tc>
                  <a:txBody>
                    <a:bodyPr/>
                    <a:lstStyle/>
                    <a:p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proliferation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7027" marR="27027" marT="13513" marB="13513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7027" marR="27027" marT="13513" marB="13513" anchor="ctr"/>
                </a:tc>
              </a:tr>
              <a:tr h="196405">
                <a:tc>
                  <a:txBody>
                    <a:bodyPr/>
                    <a:lstStyle/>
                    <a:p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ponse to lipopolysaccharide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7027" marR="27027" marT="13513" marB="13513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7027" marR="27027" marT="13513" marB="13513" anchor="ctr"/>
                </a:tc>
              </a:tr>
              <a:tr h="196405">
                <a:tc>
                  <a:txBody>
                    <a:bodyPr/>
                    <a:lstStyle/>
                    <a:p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emokine signaling pathway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7027" marR="27027" marT="13513" marB="13513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7027" marR="27027" marT="13513" marB="13513" anchor="ctr"/>
                </a:tc>
              </a:tr>
              <a:tr h="387965">
                <a:tc>
                  <a:txBody>
                    <a:bodyPr/>
                    <a:lstStyle/>
                    <a:p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 signaling pathway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7027" marR="27027" marT="13513" marB="13513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7027" marR="27027" marT="13513" marB="13513" anchor="ctr"/>
                </a:tc>
              </a:tr>
            </a:tbl>
          </a:graphicData>
        </a:graphic>
      </p:graphicFrame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20680213"/>
              </p:ext>
            </p:extLst>
          </p:nvPr>
        </p:nvGraphicFramePr>
        <p:xfrm>
          <a:off x="7274846" y="3505729"/>
          <a:ext cx="3324467" cy="26224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139610"/>
                <a:gridCol w="1184857"/>
              </a:tblGrid>
              <a:tr h="196405">
                <a:tc>
                  <a:txBody>
                    <a:bodyPr/>
                    <a:lstStyle/>
                    <a:p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regulated Biological Process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bined Score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146567">
                <a:tc>
                  <a:txBody>
                    <a:bodyPr/>
                    <a:lstStyle/>
                    <a:p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feron alpha</a:t>
                      </a:r>
                      <a:r>
                        <a:rPr lang="en-US" sz="1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ynthesis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516" marR="18516" marT="9258" marB="92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516" marR="18516" marT="9258" marB="9258" anchor="ctr"/>
                </a:tc>
              </a:tr>
              <a:tr h="196405">
                <a:tc>
                  <a:txBody>
                    <a:bodyPr/>
                    <a:lstStyle/>
                    <a:p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lium assembly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516" marR="18516" marT="9258" marB="92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516" marR="18516" marT="9258" marB="9258" anchor="ctr"/>
                </a:tc>
              </a:tr>
              <a:tr h="196405">
                <a:tc>
                  <a:txBody>
                    <a:bodyPr/>
                    <a:lstStyle/>
                    <a:p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ative regulation of mast cell degranulation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516" marR="18516" marT="9258" marB="92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516" marR="18516" marT="9258" marB="9258" anchor="ctr"/>
                </a:tc>
              </a:tr>
              <a:tr h="196405">
                <a:tc>
                  <a:txBody>
                    <a:bodyPr/>
                    <a:lstStyle/>
                    <a:p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sicle targeting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516" marR="18516" marT="9258" marB="92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516" marR="18516" marT="9258" marB="9258" anchor="ctr"/>
                </a:tc>
              </a:tr>
              <a:tr h="196405">
                <a:tc>
                  <a:txBody>
                    <a:bodyPr/>
                    <a:lstStyle/>
                    <a:p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trophil</a:t>
                      </a:r>
                      <a:r>
                        <a:rPr lang="en-US" sz="1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egranulation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516" marR="18516" marT="9258" marB="92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516" marR="18516" marT="9258" marB="9258" anchor="ctr"/>
                </a:tc>
              </a:tr>
            </a:tbl>
          </a:graphicData>
        </a:graphic>
      </p:graphicFrame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l="10506" t="10482" r="4046" b="6721"/>
          <a:stretch/>
        </p:blipFill>
        <p:spPr>
          <a:xfrm>
            <a:off x="1440717" y="782442"/>
            <a:ext cx="5091904" cy="5918934"/>
          </a:xfrm>
          <a:prstGeom prst="rect">
            <a:avLst/>
          </a:prstGeom>
        </p:spPr>
      </p:pic>
      <p:sp>
        <p:nvSpPr>
          <p:cNvPr id="10" name="Title 1"/>
          <p:cNvSpPr txBox="1">
            <a:spLocks/>
          </p:cNvSpPr>
          <p:nvPr/>
        </p:nvSpPr>
        <p:spPr>
          <a:xfrm>
            <a:off x="45046" y="40851"/>
            <a:ext cx="2980080" cy="421115"/>
          </a:xfrm>
          <a:prstGeom prst="rect">
            <a:avLst/>
          </a:prstGeom>
        </p:spPr>
        <p:txBody>
          <a:bodyPr vert="horz" lIns="68580" tIns="34291" rIns="68580" bIns="34291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809653" y="597776"/>
            <a:ext cx="631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643782" y="597776"/>
            <a:ext cx="631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Straight Connector 3"/>
          <p:cNvCxnSpPr/>
          <p:nvPr/>
        </p:nvCxnSpPr>
        <p:spPr>
          <a:xfrm>
            <a:off x="1440717" y="713687"/>
            <a:ext cx="2242641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3801745" y="713687"/>
            <a:ext cx="2242641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2245254" y="398696"/>
            <a:ext cx="6335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635016" y="398696"/>
            <a:ext cx="7247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54977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15</TotalTime>
  <Words>61</Words>
  <Application>Microsoft Office PowerPoint</Application>
  <PresentationFormat>Widescreen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MM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Mouton</dc:creator>
  <cp:lastModifiedBy>Merry Lindsey</cp:lastModifiedBy>
  <cp:revision>21</cp:revision>
  <dcterms:created xsi:type="dcterms:W3CDTF">2018-03-10T19:30:31Z</dcterms:created>
  <dcterms:modified xsi:type="dcterms:W3CDTF">2018-04-03T23:49:55Z</dcterms:modified>
</cp:coreProperties>
</file>